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1" r:id="rId5"/>
    <p:sldId id="262" r:id="rId6"/>
    <p:sldId id="260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02" y="-4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29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4485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1658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7632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1541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9749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5522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367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57576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3943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3054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9DDCF-E632-4FDB-B3B2-3966A6F5A5B8}" type="datetimeFigureOut">
              <a:rPr lang="zh-CN" altLang="en-US" smtClean="0"/>
              <a:t>2020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121A4F-8FB3-4CDD-8564-E66E845A6AF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0493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tif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1950" y="0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2B</a:t>
            </a:r>
            <a:endParaRPr lang="zh-CN" altLang="en-US" dirty="0"/>
          </a:p>
        </p:txBody>
      </p:sp>
      <p:pic>
        <p:nvPicPr>
          <p:cNvPr id="1026" name="Picture 2" descr="D:\工作\投稿中\马新伟王晓琪\三部数据 2020.11.4\马新伟-吴艮艮 2020.11.4\45-G20051201\45-G20051201\1\GAPDH 原图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1720" y="1268760"/>
            <a:ext cx="5400675" cy="1171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D:\工作\投稿中\马新伟王晓琪\三部数据 2020.11.4\马新伟-吴艮艮 2020.11.4\45-G20051201\45-G20051201\1\IRF6 原图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1719" y="-266110"/>
            <a:ext cx="5400675" cy="15668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251520" y="2996952"/>
            <a:ext cx="10441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2D</a:t>
            </a:r>
            <a:endParaRPr lang="zh-CN" altLang="en-US" dirty="0"/>
          </a:p>
        </p:txBody>
      </p:sp>
      <p:pic>
        <p:nvPicPr>
          <p:cNvPr id="1028" name="Picture 4" descr="D:\工作\投稿中\马新伟王晓琪\三部数据 2020.11.4\马新伟-吴艮艮 2020.11.4\45-G20051201\45-G20051201\2\GAPDH 原图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4772" y="4725144"/>
            <a:ext cx="5400675" cy="14890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D:\工作\投稿中\马新伟王晓琪\三部数据 2020.11.4\马新伟-吴艮艮 2020.11.4\45-G20051201\45-G20051201\2\IRF6 原图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4772" y="3318441"/>
            <a:ext cx="5400675" cy="1406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142002" y="3876213"/>
            <a:ext cx="61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RF6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818416" y="5100349"/>
            <a:ext cx="935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399952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188640"/>
            <a:ext cx="1656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6B</a:t>
            </a:r>
            <a:endParaRPr lang="zh-CN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69145" y="3429000"/>
            <a:ext cx="1656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6D</a:t>
            </a:r>
            <a:endParaRPr lang="zh-CN" altLang="en-US" dirty="0"/>
          </a:p>
        </p:txBody>
      </p:sp>
      <p:pic>
        <p:nvPicPr>
          <p:cNvPr id="2050" name="Picture 2" descr="D:\工作\投稿中\马新伟王晓琪\三部数据 2020.11.4\马新伟-吴艮艮 2020.11.4\45-G20051201\45-G20051201\3\GAPDH 原图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1662" y="1447196"/>
            <a:ext cx="5400675" cy="1349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D:\工作\投稿中\马新伟王晓琪\三部数据 2020.11.4\马新伟-吴艮艮 2020.11.4\45-G20051201\45-G20051201\3\KIF20A 原图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1296" y="74134"/>
            <a:ext cx="5400675" cy="14557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827584" y="658635"/>
            <a:ext cx="1044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KIF20A 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936008" y="1882771"/>
            <a:ext cx="935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pic>
        <p:nvPicPr>
          <p:cNvPr id="2052" name="Picture 4" descr="D:\工作\投稿中\马新伟王晓琪\三部数据 2020.11.4\马新伟-吴艮艮 2020.11.4\45-G20051201\45-G20051201\4\GAPDH 原图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1661" y="4941168"/>
            <a:ext cx="5400675" cy="17287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D:\工作\投稿中\马新伟王晓琪\三部数据 2020.11.4\马新伟-吴艮艮 2020.11.4\45-G20051201\45-G20051201\4\KIF20A 原图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2392" y="3699913"/>
            <a:ext cx="5400675" cy="1374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719160" y="4386228"/>
            <a:ext cx="1044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KIF20A 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827584" y="5610364"/>
            <a:ext cx="935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816374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21999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9D</a:t>
            </a:r>
            <a:endParaRPr lang="zh-CN" altLang="en-US" dirty="0"/>
          </a:p>
        </p:txBody>
      </p:sp>
      <p:pic>
        <p:nvPicPr>
          <p:cNvPr id="3074" name="Picture 2" descr="D:\工作\投稿中\马新伟王晓琪\三部数据 2020.11.4\马新伟-吴艮艮 2020.11.4\45-G20051201\45-G20051201\5\IRF6 原图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4399" y="785110"/>
            <a:ext cx="5400675" cy="13541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D:\工作\投稿中\马新伟王晓琪\三部数据 2020.11.4\马新伟-吴艮艮 2020.11.4\45-G20051201\45-G20051201\5\GAPDH 原图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415" y="2132856"/>
            <a:ext cx="5400675" cy="1981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610736" y="1529988"/>
            <a:ext cx="1044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KIF20A 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19160" y="2754124"/>
            <a:ext cx="935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432957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188640"/>
            <a:ext cx="1656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prstClr val="black"/>
                </a:solidFill>
              </a:rPr>
              <a:t>figure10B</a:t>
            </a:r>
            <a:endParaRPr lang="zh-CN" altLang="en-US" dirty="0">
              <a:solidFill>
                <a:prstClr val="black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69145" y="3429000"/>
            <a:ext cx="1656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prstClr val="black"/>
                </a:solidFill>
              </a:rPr>
              <a:t>figure10D</a:t>
            </a:r>
            <a:endParaRPr lang="zh-CN" altLang="en-US" dirty="0">
              <a:solidFill>
                <a:prstClr val="black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27584" y="658635"/>
            <a:ext cx="1044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prstClr val="black"/>
                </a:solidFill>
              </a:rPr>
              <a:t>KIF20A </a:t>
            </a:r>
            <a:endParaRPr lang="zh-CN" altLang="en-US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36008" y="1882771"/>
            <a:ext cx="935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prstClr val="black"/>
                </a:solidFill>
              </a:rPr>
              <a:t>GAPDH</a:t>
            </a:r>
            <a:endParaRPr lang="zh-CN" altLang="en-US" dirty="0">
              <a:solidFill>
                <a:prstClr val="black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19160" y="4386228"/>
            <a:ext cx="1044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prstClr val="black"/>
                </a:solidFill>
              </a:rPr>
              <a:t>KIF20A </a:t>
            </a:r>
            <a:endParaRPr lang="zh-CN" altLang="en-US" dirty="0">
              <a:solidFill>
                <a:prstClr val="black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27584" y="5610364"/>
            <a:ext cx="935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prstClr val="black"/>
                </a:solidFill>
              </a:rPr>
              <a:t>GAPDH</a:t>
            </a:r>
            <a:endParaRPr lang="zh-CN" altLang="en-US" dirty="0">
              <a:solidFill>
                <a:prstClr val="black"/>
              </a:solidFill>
            </a:endParaRPr>
          </a:p>
        </p:txBody>
      </p:sp>
      <p:pic>
        <p:nvPicPr>
          <p:cNvPr id="4098" name="Picture 2" descr="D:\工作\投稿中\马新伟王晓琪\三部数据 2020.11.4\马新伟-吴艮艮 2020.11.4\45-G20051201\45-G20051201\6\KIF20A 原图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1661" y="-32722"/>
            <a:ext cx="5400675" cy="1382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D:\工作\投稿中\马新伟王晓琪\三部数据 2020.11.4\马新伟-吴艮艮 2020.11.4\45-G20051201\45-G20051201\6\GAPDH 原图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0915" y="1257300"/>
            <a:ext cx="5400675" cy="2171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D:\工作\投稿中\马新伟王晓琪\三部数据 2020.11.4\马新伟-吴艮艮 2020.11.4\45-G20051201\45-G20051201\7\KIF20A 原图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6770" y="3576016"/>
            <a:ext cx="5400675" cy="2330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D:\工作\投稿中\马新伟王晓琪\三部数据 2020.11.4\马新伟-吴艮艮 2020.11.4\45-G20051201\45-G20051201\7\GAPDH 原图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6771" y="5795030"/>
            <a:ext cx="5400675" cy="1763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837981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219998"/>
            <a:ext cx="1403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13D</a:t>
            </a:r>
            <a:endParaRPr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862053" y="3651950"/>
            <a:ext cx="1044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KIF20A </a:t>
            </a:r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10736" y="6775634"/>
            <a:ext cx="935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pic>
        <p:nvPicPr>
          <p:cNvPr id="6146" name="Picture 2" descr="D:\工作\投稿中\马新伟王晓琪\三部数据 2020.11.4\马新伟-吴艮艮 2020.11.4\45-G20051201\45-G20051201\8\KIF20A 原图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1720" y="2261023"/>
            <a:ext cx="5400675" cy="31511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D:\工作\投稿中\马新伟王晓琪\三部数据 2020.11.4\马新伟-吴艮艮 2020.11.4\45-G20051201\45-G20051201\8\GAPDH 原图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67457" y="5412210"/>
            <a:ext cx="5400675" cy="34655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D:\工作\投稿中\马新伟王晓琪\三部数据 2020.11.4\马新伟-吴艮艮 2020.11.4\45-G20051201\45-G20051201\8\IRF6 原图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1720" y="-29740"/>
            <a:ext cx="5400675" cy="22907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862053" y="908720"/>
            <a:ext cx="1044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RF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506952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9453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23</Words>
  <Application>Microsoft Office PowerPoint</Application>
  <PresentationFormat>全屏显示(4:3)</PresentationFormat>
  <Paragraphs>23</Paragraphs>
  <Slides>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dhw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2</cp:revision>
  <dcterms:created xsi:type="dcterms:W3CDTF">2020-12-15T02:44:56Z</dcterms:created>
  <dcterms:modified xsi:type="dcterms:W3CDTF">2020-12-15T03:01:00Z</dcterms:modified>
</cp:coreProperties>
</file>